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04" r:id="rId2"/>
  </p:sldIdLst>
  <p:sldSz cx="6858000" cy="9144000" type="screen4x3"/>
  <p:notesSz cx="6794500" cy="9931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75840" autoAdjust="0"/>
  </p:normalViewPr>
  <p:slideViewPr>
    <p:cSldViewPr>
      <p:cViewPr>
        <p:scale>
          <a:sx n="66" d="100"/>
          <a:sy n="66" d="100"/>
        </p:scale>
        <p:origin x="3378" y="4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ad.ucl.ac.uk\slms\Group\Cancer\SignalPathways\Pablo\NF2%20paper%202016\Silvia%20proteomics\CDC73_HT1080vsMDA231-Silvi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'HT-MDA D6.8 BP MF CC-PRV'!$C$49</c:f>
              <c:strCache>
                <c:ptCount val="1"/>
                <c:pt idx="0">
                  <c:v>Enrichment Score: Medium</c:v>
                </c:pt>
              </c:strCache>
            </c:strRef>
          </c:tx>
          <c:invertIfNegative val="0"/>
          <c:cat>
            <c:strRef>
              <c:f>'HT-MDA D6.8 BP MF CC-PRV'!$B$50:$B$54</c:f>
              <c:strCache>
                <c:ptCount val="5"/>
                <c:pt idx="0">
                  <c:v>chromatin binding</c:v>
                </c:pt>
                <c:pt idx="1">
                  <c:v>cell-cell adhesion</c:v>
                </c:pt>
                <c:pt idx="2">
                  <c:v>Cdc73/Paf1 complex</c:v>
                </c:pt>
                <c:pt idx="3">
                  <c:v>mRNA processing</c:v>
                </c:pt>
                <c:pt idx="4">
                  <c:v>mRNA splicing, via spliceosome</c:v>
                </c:pt>
              </c:strCache>
            </c:strRef>
          </c:cat>
          <c:val>
            <c:numRef>
              <c:f>'HT-MDA D6.8 BP MF CC-PRV'!$C$50:$C$54</c:f>
              <c:numCache>
                <c:formatCode>0.00</c:formatCode>
                <c:ptCount val="5"/>
                <c:pt idx="0">
                  <c:v>0.61281666922706002</c:v>
                </c:pt>
                <c:pt idx="1">
                  <c:v>1.9519146463069701</c:v>
                </c:pt>
                <c:pt idx="2">
                  <c:v>3.6083858267398301</c:v>
                </c:pt>
                <c:pt idx="3">
                  <c:v>3.6460239826443002</c:v>
                </c:pt>
                <c:pt idx="4">
                  <c:v>3.786103086580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119-4CAD-BEAE-FA03E22C4F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70723936"/>
        <c:axId val="541891392"/>
      </c:barChart>
      <c:catAx>
        <c:axId val="370723936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b="0"/>
            </a:pPr>
            <a:endParaRPr lang="en-US"/>
          </a:p>
        </c:txPr>
        <c:crossAx val="541891392"/>
        <c:crosses val="autoZero"/>
        <c:auto val="1"/>
        <c:lblAlgn val="ctr"/>
        <c:lblOffset val="100"/>
        <c:noMultiLvlLbl val="0"/>
      </c:catAx>
      <c:valAx>
        <c:axId val="541891392"/>
        <c:scaling>
          <c:orientation val="minMax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Enrichment Score</a:t>
                </a:r>
              </a:p>
            </c:rich>
          </c:tx>
          <c:overlay val="0"/>
        </c:title>
        <c:numFmt formatCode="0.0" sourceLinked="0"/>
        <c:majorTickMark val="out"/>
        <c:minorTickMark val="none"/>
        <c:tickLblPos val="nextTo"/>
        <c:crossAx val="37072393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8645" y="0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F8D72DD-44E9-47CF-B755-24FD5FCAA12B}" type="datetimeFigureOut">
              <a:rPr lang="en-GB" smtClean="0"/>
              <a:t>06/07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33106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8645" y="9433106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6A0BF2-3B54-4910-AAB0-3BD395A574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912892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66D4B14-732C-45D7-AC16-2CC03C63C930}" type="datetimeFigureOut">
              <a:rPr lang="en-GB" smtClean="0"/>
              <a:t>06/07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1838" y="744538"/>
            <a:ext cx="2790825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7415"/>
            <a:ext cx="5435600" cy="446913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3106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8645" y="9433106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AF3E77-D6B1-41E2-9DAF-613D74365A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96171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baseline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6AF3E77-D6B1-41E2-9DAF-613D74365A4D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26073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B0D27-EAA5-4780-A463-204953A3D71B}" type="datetimeFigureOut">
              <a:rPr lang="en-GB" smtClean="0"/>
              <a:t>06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DE504-FF5C-4486-90A0-B37A09D026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04025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B0D27-EAA5-4780-A463-204953A3D71B}" type="datetimeFigureOut">
              <a:rPr lang="en-GB" smtClean="0"/>
              <a:t>06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DE504-FF5C-4486-90A0-B37A09D026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2604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B0D27-EAA5-4780-A463-204953A3D71B}" type="datetimeFigureOut">
              <a:rPr lang="en-GB" smtClean="0"/>
              <a:t>06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DE504-FF5C-4486-90A0-B37A09D026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55881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B0D27-EAA5-4780-A463-204953A3D71B}" type="datetimeFigureOut">
              <a:rPr lang="en-GB" smtClean="0"/>
              <a:t>06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DE504-FF5C-4486-90A0-B37A09D026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1747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B0D27-EAA5-4780-A463-204953A3D71B}" type="datetimeFigureOut">
              <a:rPr lang="en-GB" smtClean="0"/>
              <a:t>06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DE504-FF5C-4486-90A0-B37A09D026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37513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B0D27-EAA5-4780-A463-204953A3D71B}" type="datetimeFigureOut">
              <a:rPr lang="en-GB" smtClean="0"/>
              <a:t>06/07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DE504-FF5C-4486-90A0-B37A09D026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84253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B0D27-EAA5-4780-A463-204953A3D71B}" type="datetimeFigureOut">
              <a:rPr lang="en-GB" smtClean="0"/>
              <a:t>06/07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DE504-FF5C-4486-90A0-B37A09D026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5670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B0D27-EAA5-4780-A463-204953A3D71B}" type="datetimeFigureOut">
              <a:rPr lang="en-GB" smtClean="0"/>
              <a:t>06/07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DE504-FF5C-4486-90A0-B37A09D026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11417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B0D27-EAA5-4780-A463-204953A3D71B}" type="datetimeFigureOut">
              <a:rPr lang="en-GB" smtClean="0"/>
              <a:t>06/07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DE504-FF5C-4486-90A0-B37A09D026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78869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B0D27-EAA5-4780-A463-204953A3D71B}" type="datetimeFigureOut">
              <a:rPr lang="en-GB" smtClean="0"/>
              <a:t>06/07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DE504-FF5C-4486-90A0-B37A09D026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29233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B0D27-EAA5-4780-A463-204953A3D71B}" type="datetimeFigureOut">
              <a:rPr lang="en-GB" smtClean="0"/>
              <a:t>06/07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DE504-FF5C-4486-90A0-B37A09D026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21412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6B0D27-EAA5-4780-A463-204953A3D71B}" type="datetimeFigureOut">
              <a:rPr lang="en-GB" smtClean="0"/>
              <a:t>06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EDE504-FF5C-4486-90A0-B37A09D026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63665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407" t="2798" r="9724" b="4020"/>
          <a:stretch/>
        </p:blipFill>
        <p:spPr>
          <a:xfrm>
            <a:off x="813469" y="2842664"/>
            <a:ext cx="2177507" cy="2540426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23" t="3119" r="9234" b="4024"/>
          <a:stretch/>
        </p:blipFill>
        <p:spPr>
          <a:xfrm>
            <a:off x="3097145" y="2833435"/>
            <a:ext cx="2204063" cy="2531575"/>
          </a:xfrm>
          <a:prstGeom prst="rect">
            <a:avLst/>
          </a:prstGeom>
        </p:spPr>
      </p:pic>
      <p:sp>
        <p:nvSpPr>
          <p:cNvPr id="26" name="TextBox 25"/>
          <p:cNvSpPr txBox="1"/>
          <p:nvPr/>
        </p:nvSpPr>
        <p:spPr>
          <a:xfrm>
            <a:off x="1340768" y="2555776"/>
            <a:ext cx="13681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/>
              <a:t>HT1080</a:t>
            </a:r>
            <a:r>
              <a:rPr lang="en-GB" sz="1000" b="1" dirty="0"/>
              <a:t> (NF </a:t>
            </a:r>
            <a:r>
              <a:rPr lang="en-GB" sz="1000" b="1" dirty="0" err="1"/>
              <a:t>wt</a:t>
            </a:r>
            <a:r>
              <a:rPr lang="en-GB" sz="1000" b="1" dirty="0"/>
              <a:t>)</a:t>
            </a:r>
          </a:p>
        </p:txBody>
      </p:sp>
      <p:pic>
        <p:nvPicPr>
          <p:cNvPr id="27" name="Picture 2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66" t="18201" r="9476" b="23863"/>
          <a:stretch/>
        </p:blipFill>
        <p:spPr>
          <a:xfrm>
            <a:off x="4293096" y="827584"/>
            <a:ext cx="2304256" cy="1665452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3429000" y="2555776"/>
            <a:ext cx="17487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/>
              <a:t>MDA-MB-231</a:t>
            </a:r>
            <a:r>
              <a:rPr lang="en-GB" sz="1000" b="1" dirty="0"/>
              <a:t> (NF2 </a:t>
            </a:r>
            <a:r>
              <a:rPr lang="en-GB" sz="1000" b="1" dirty="0" err="1"/>
              <a:t>mut</a:t>
            </a:r>
            <a:r>
              <a:rPr lang="en-GB" sz="1000" b="1" dirty="0"/>
              <a:t>)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476672" y="61156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A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548680" y="248376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C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4149080" y="61156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B</a:t>
            </a:r>
          </a:p>
        </p:txBody>
      </p:sp>
      <p:graphicFrame>
        <p:nvGraphicFramePr>
          <p:cNvPr id="23" name="Chart 22"/>
          <p:cNvGraphicFramePr>
            <a:graphicFrameLocks/>
          </p:cNvGraphicFramePr>
          <p:nvPr/>
        </p:nvGraphicFramePr>
        <p:xfrm>
          <a:off x="0" y="971600"/>
          <a:ext cx="4221088" cy="15121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24804947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667</TotalTime>
  <Words>16</Words>
  <Application>Microsoft Office PowerPoint</Application>
  <PresentationFormat>On-screen Show (4:3)</PresentationFormat>
  <Paragraphs>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C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blo Rodriguez-Viciana</dc:creator>
  <cp:lastModifiedBy>Rodriguez-Viciana, Pablo</cp:lastModifiedBy>
  <cp:revision>311</cp:revision>
  <cp:lastPrinted>2016-11-23T15:50:56Z</cp:lastPrinted>
  <dcterms:created xsi:type="dcterms:W3CDTF">2013-05-02T15:08:20Z</dcterms:created>
  <dcterms:modified xsi:type="dcterms:W3CDTF">2021-07-06T11:29:51Z</dcterms:modified>
</cp:coreProperties>
</file>